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7B57B"/>
    <a:srgbClr val="E7F5EC"/>
    <a:srgbClr val="DFF1E6"/>
    <a:srgbClr val="ECF3FA"/>
    <a:srgbClr val="D4ECDD"/>
    <a:srgbClr val="BBE1C9"/>
    <a:srgbClr val="DEEBF7"/>
    <a:srgbClr val="C7F1F5"/>
    <a:srgbClr val="6DBF8C"/>
    <a:srgbClr val="84C4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249" autoAdjust="0"/>
  </p:normalViewPr>
  <p:slideViewPr>
    <p:cSldViewPr snapToGrid="0" showGuides="1">
      <p:cViewPr varScale="1">
        <p:scale>
          <a:sx n="46" d="100"/>
          <a:sy n="46" d="100"/>
        </p:scale>
        <p:origin x="2262" y="54"/>
      </p:cViewPr>
      <p:guideLst>
        <p:guide orient="horz" pos="3143"/>
        <p:guide pos="213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viewProps" Target="viewProps.xml"/><Relationship Id="rId5" Type="http://schemas.openxmlformats.org/officeDocument/2006/relationships/font" Target="fonts/font2.fntdata"/><Relationship Id="rId10" Type="http://schemas.openxmlformats.org/officeDocument/2006/relationships/presProps" Target="presProps.xml"/><Relationship Id="rId4" Type="http://schemas.openxmlformats.org/officeDocument/2006/relationships/font" Target="fonts/font1.fntdata"/><Relationship Id="rId9" Type="http://schemas.openxmlformats.org/officeDocument/2006/relationships/font" Target="fonts/font6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344129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>
            <a:extLst>
              <a:ext uri="{FF2B5EF4-FFF2-40B4-BE49-F238E27FC236}">
                <a16:creationId xmlns:a16="http://schemas.microsoft.com/office/drawing/2014/main" id="{64CF6208-865F-4686-8D35-358704FB4351}"/>
              </a:ext>
            </a:extLst>
          </p:cNvPr>
          <p:cNvSpPr txBox="1"/>
          <p:nvPr/>
        </p:nvSpPr>
        <p:spPr>
          <a:xfrm>
            <a:off x="512668" y="3916912"/>
            <a:ext cx="5759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1 |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Effect of growing conditions on major terpenoid profile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rincipal component analysis to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epict the impact of homogenous and heterogenous plot conditions on GC-MS features.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5BAB7CCA-E4E9-6E2F-4053-7AE6C9A5F3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9000" y="427985"/>
            <a:ext cx="2880000" cy="33249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018987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37</TotalTime>
  <Words>31</Words>
  <Application>Microsoft Office PowerPoint</Application>
  <PresentationFormat>Format A4 (210 x 297 mm)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 Light</vt:lpstr>
      <vt:lpstr>Calibri</vt:lpstr>
      <vt:lpstr>Arial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520</cp:revision>
  <dcterms:created xsi:type="dcterms:W3CDTF">2020-07-29T08:33:47Z</dcterms:created>
  <dcterms:modified xsi:type="dcterms:W3CDTF">2023-02-15T14:10:35Z</dcterms:modified>
</cp:coreProperties>
</file>